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4797748-C890-4EEB-B492-A597EC491D4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just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l Figure 1. IL-18 plasma levels and IL-18 cardiac mRNA after Western diet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Eight weeks of Western diet induced a significant increase of IL-18 plasma levels (Panel A) and IL-18 cardiac mRNA (Panel B). # =p&lt;0.05 vs Standard die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380B4CE-892D-4E35-BF9B-EC0EC6CDC7C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C0D851-C9CF-4878-84AD-553A22DE98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0C8667-F419-4863-A253-8E92BCF2AF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0719A1-2EC9-425E-B78E-8A3154C0CE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91997-A7E4-4EAE-8A8F-1D3B6BD8B1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7BACB9-B9BD-4A94-AC99-FCA9943D32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5EBDAC-B081-4BB9-8B48-58854894AF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DA57F0-B718-4AA4-BD12-F382CFD47C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ABF52B-F172-48DA-9389-36B9631859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286C45-1F95-4BA6-8985-EB66D503CC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2C578-2DD9-4F0A-8229-8481947BD6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7DC387-C40D-49E0-80DC-62B98E5708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1B7FF4-A349-4F6B-A7E2-A81F97383D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288F15F-C355-475D-A281-6343BF09241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7"/>
          <p:cNvSpPr/>
          <p:nvPr/>
        </p:nvSpPr>
        <p:spPr>
          <a:xfrm>
            <a:off x="274680" y="7842240"/>
            <a:ext cx="635004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upplemental Figure 1. IL-18 plasma levels and IL-18 cardiac mRNA after Western diet.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Eight weeks of Western diet induced a significant increase of IL-18 plasma levels (Panel A) and IL-18 cardiac mRNA (Panel B). # =p&lt;0.05 vs Standard die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3" descr=""/>
          <p:cNvPicPr/>
          <p:nvPr/>
        </p:nvPicPr>
        <p:blipFill>
          <a:blip r:embed="rId1"/>
          <a:stretch/>
        </p:blipFill>
        <p:spPr>
          <a:xfrm>
            <a:off x="314280" y="2149560"/>
            <a:ext cx="6213600" cy="4103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2-16T01:08:33Z</dcterms:created>
  <dc:creator>somtech</dc:creator>
  <dc:description/>
  <dc:language>en-US</dc:language>
  <cp:lastModifiedBy>ravikumar.n</cp:lastModifiedBy>
  <cp:lastPrinted>2016-07-15T14:08:26Z</cp:lastPrinted>
  <dcterms:modified xsi:type="dcterms:W3CDTF">2017-03-10T09:44:35Z</dcterms:modified>
  <cp:revision>231</cp:revision>
  <dc:subject/>
  <dc:title>PowerPoint Presentation</dc:title>
</cp:coreProperties>
</file>